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280746B-929B-FF4F-8A50-E56992B3C8A0}" v="1" dt="2022-12-06T10:06:58.48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74"/>
    <p:restoredTop sz="96327"/>
  </p:normalViewPr>
  <p:slideViewPr>
    <p:cSldViewPr snapToGrid="0" snapToObjects="1">
      <p:cViewPr>
        <p:scale>
          <a:sx n="215" d="100"/>
          <a:sy n="215" d="100"/>
        </p:scale>
        <p:origin x="760" y="-78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dachi Hiroaki" userId="c399da78-718a-421c-91d4-5860850c1366" providerId="ADAL" clId="{3280746B-929B-FF4F-8A50-E56992B3C8A0}"/>
    <pc:docChg chg="custSel addSld modSld">
      <pc:chgData name="Adachi Hiroaki" userId="c399da78-718a-421c-91d4-5860850c1366" providerId="ADAL" clId="{3280746B-929B-FF4F-8A50-E56992B3C8A0}" dt="2022-12-06T10:09:56.070" v="82" actId="20577"/>
      <pc:docMkLst>
        <pc:docMk/>
      </pc:docMkLst>
      <pc:sldChg chg="modSp mod">
        <pc:chgData name="Adachi Hiroaki" userId="c399da78-718a-421c-91d4-5860850c1366" providerId="ADAL" clId="{3280746B-929B-FF4F-8A50-E56992B3C8A0}" dt="2022-11-08T07:26:35.730" v="52" actId="20577"/>
        <pc:sldMkLst>
          <pc:docMk/>
          <pc:sldMk cId="1106958044" sldId="256"/>
        </pc:sldMkLst>
        <pc:spChg chg="mod">
          <ac:chgData name="Adachi Hiroaki" userId="c399da78-718a-421c-91d4-5860850c1366" providerId="ADAL" clId="{3280746B-929B-FF4F-8A50-E56992B3C8A0}" dt="2022-11-08T07:26:35.730" v="52" actId="20577"/>
          <ac:spMkLst>
            <pc:docMk/>
            <pc:sldMk cId="1106958044" sldId="256"/>
            <ac:spMk id="32" creationId="{9973E583-AA61-7A48-B7CB-4920B76C6CC8}"/>
          </ac:spMkLst>
        </pc:spChg>
      </pc:sldChg>
      <pc:sldChg chg="addSp delSp modSp new mod">
        <pc:chgData name="Adachi Hiroaki" userId="c399da78-718a-421c-91d4-5860850c1366" providerId="ADAL" clId="{3280746B-929B-FF4F-8A50-E56992B3C8A0}" dt="2022-12-06T10:09:56.070" v="82" actId="20577"/>
        <pc:sldMkLst>
          <pc:docMk/>
          <pc:sldMk cId="2025297796" sldId="257"/>
        </pc:sldMkLst>
        <pc:spChg chg="del">
          <ac:chgData name="Adachi Hiroaki" userId="c399da78-718a-421c-91d4-5860850c1366" providerId="ADAL" clId="{3280746B-929B-FF4F-8A50-E56992B3C8A0}" dt="2022-12-06T10:06:33.356" v="54" actId="478"/>
          <ac:spMkLst>
            <pc:docMk/>
            <pc:sldMk cId="2025297796" sldId="257"/>
            <ac:spMk id="2" creationId="{F1CE1603-3972-0DBF-86A0-27AC401E2C1B}"/>
          </ac:spMkLst>
        </pc:spChg>
        <pc:spChg chg="del">
          <ac:chgData name="Adachi Hiroaki" userId="c399da78-718a-421c-91d4-5860850c1366" providerId="ADAL" clId="{3280746B-929B-FF4F-8A50-E56992B3C8A0}" dt="2022-12-06T10:06:33.356" v="54" actId="478"/>
          <ac:spMkLst>
            <pc:docMk/>
            <pc:sldMk cId="2025297796" sldId="257"/>
            <ac:spMk id="3" creationId="{F356FAC8-8E5D-C82F-7E09-4A6811EB8ED3}"/>
          </ac:spMkLst>
        </pc:spChg>
        <pc:spChg chg="add mod">
          <ac:chgData name="Adachi Hiroaki" userId="c399da78-718a-421c-91d4-5860850c1366" providerId="ADAL" clId="{3280746B-929B-FF4F-8A50-E56992B3C8A0}" dt="2022-12-06T10:09:56.070" v="82" actId="20577"/>
          <ac:spMkLst>
            <pc:docMk/>
            <pc:sldMk cId="2025297796" sldId="257"/>
            <ac:spMk id="4" creationId="{88FE003D-E7CF-ABAA-D6FB-B73536D5BCF4}"/>
          </ac:spMkLst>
        </pc:spChg>
      </pc:sldChg>
    </pc:docChg>
  </pc:docChgLst>
  <pc:docChgLst>
    <pc:chgData name="Adachi Hiroaki" userId="c399da78-718a-421c-91d4-5860850c1366" providerId="ADAL" clId="{75E8E354-F2DA-FF42-A19C-7824C3B9B8B8}"/>
    <pc:docChg chg="undo custSel modSld">
      <pc:chgData name="Adachi Hiroaki" userId="c399da78-718a-421c-91d4-5860850c1366" providerId="ADAL" clId="{75E8E354-F2DA-FF42-A19C-7824C3B9B8B8}" dt="2022-09-27T08:01:09.672" v="91" actId="1038"/>
      <pc:docMkLst>
        <pc:docMk/>
      </pc:docMkLst>
      <pc:sldChg chg="modSp mod">
        <pc:chgData name="Adachi Hiroaki" userId="c399da78-718a-421c-91d4-5860850c1366" providerId="ADAL" clId="{75E8E354-F2DA-FF42-A19C-7824C3B9B8B8}" dt="2022-09-27T08:01:09.672" v="91" actId="1038"/>
        <pc:sldMkLst>
          <pc:docMk/>
          <pc:sldMk cId="1106958044" sldId="256"/>
        </pc:sldMkLst>
        <pc:spChg chg="mod">
          <ac:chgData name="Adachi Hiroaki" userId="c399da78-718a-421c-91d4-5860850c1366" providerId="ADAL" clId="{75E8E354-F2DA-FF42-A19C-7824C3B9B8B8}" dt="2022-09-27T08:01:09.672" v="91" actId="1038"/>
          <ac:spMkLst>
            <pc:docMk/>
            <pc:sldMk cId="1106958044" sldId="256"/>
            <ac:spMk id="32" creationId="{9973E583-AA61-7A48-B7CB-4920B76C6CC8}"/>
          </ac:spMkLst>
        </pc:spChg>
        <pc:spChg chg="mod">
          <ac:chgData name="Adachi Hiroaki" userId="c399da78-718a-421c-91d4-5860850c1366" providerId="ADAL" clId="{75E8E354-F2DA-FF42-A19C-7824C3B9B8B8}" dt="2022-09-12T05:26:58.779" v="5" actId="20577"/>
          <ac:spMkLst>
            <pc:docMk/>
            <pc:sldMk cId="1106958044" sldId="256"/>
            <ac:spMk id="42" creationId="{EA1D7486-26F7-7149-88C9-58F1A941F08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2/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807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2/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478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2/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604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2/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647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2/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907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2/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47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2/6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2/6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371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2/6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171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2/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400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2/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02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5596E9-F1A3-9140-B45A-F3CD60641B70}" type="datetimeFigureOut">
              <a:rPr lang="en-US" smtClean="0"/>
              <a:t>12/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123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Rectangle 25">
            <a:extLst>
              <a:ext uri="{FF2B5EF4-FFF2-40B4-BE49-F238E27FC236}">
                <a16:creationId xmlns:a16="http://schemas.microsoft.com/office/drawing/2014/main" id="{43C93ADA-611B-5B4F-9FB5-12281BAA8330}"/>
              </a:ext>
            </a:extLst>
          </p:cNvPr>
          <p:cNvSpPr/>
          <p:nvPr/>
        </p:nvSpPr>
        <p:spPr>
          <a:xfrm>
            <a:off x="58004" y="6234737"/>
            <a:ext cx="6754598" cy="31130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4BC742CA-7806-BE4B-8E16-85CE9F9794C1}"/>
              </a:ext>
            </a:extLst>
          </p:cNvPr>
          <p:cNvSpPr/>
          <p:nvPr/>
        </p:nvSpPr>
        <p:spPr>
          <a:xfrm>
            <a:off x="58004" y="5621131"/>
            <a:ext cx="6754598" cy="31130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EFC13851-8D6E-3F4A-A9DF-622597C261F7}"/>
              </a:ext>
            </a:extLst>
          </p:cNvPr>
          <p:cNvSpPr/>
          <p:nvPr/>
        </p:nvSpPr>
        <p:spPr>
          <a:xfrm>
            <a:off x="58004" y="6843065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8148961D-17EC-4F4A-931C-E5D2B35273A2}"/>
              </a:ext>
            </a:extLst>
          </p:cNvPr>
          <p:cNvSpPr/>
          <p:nvPr/>
        </p:nvSpPr>
        <p:spPr>
          <a:xfrm>
            <a:off x="58004" y="5010343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794C23B0-47AD-DE47-8419-86D24689AEA3}"/>
              </a:ext>
            </a:extLst>
          </p:cNvPr>
          <p:cNvSpPr/>
          <p:nvPr/>
        </p:nvSpPr>
        <p:spPr>
          <a:xfrm>
            <a:off x="58004" y="4399555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9AF246CF-9BB9-214B-9AD0-CA20C5A5C8CC}"/>
              </a:ext>
            </a:extLst>
          </p:cNvPr>
          <p:cNvSpPr/>
          <p:nvPr/>
        </p:nvSpPr>
        <p:spPr>
          <a:xfrm>
            <a:off x="58004" y="3783134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5AAB0EA-0EE2-F046-BD5F-4E07FE2CA1F8}"/>
              </a:ext>
            </a:extLst>
          </p:cNvPr>
          <p:cNvSpPr/>
          <p:nvPr/>
        </p:nvSpPr>
        <p:spPr>
          <a:xfrm>
            <a:off x="58004" y="3169331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8EEEA8ED-DF50-F142-844E-AB93237D27FC}"/>
              </a:ext>
            </a:extLst>
          </p:cNvPr>
          <p:cNvSpPr/>
          <p:nvPr/>
        </p:nvSpPr>
        <p:spPr>
          <a:xfrm>
            <a:off x="58004" y="2576182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279C0064-7685-404C-B7D9-59F421A7E266}"/>
              </a:ext>
            </a:extLst>
          </p:cNvPr>
          <p:cNvSpPr/>
          <p:nvPr/>
        </p:nvSpPr>
        <p:spPr>
          <a:xfrm>
            <a:off x="58004" y="135035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F184773-05EA-404C-9A6D-15233C400BA8}"/>
              </a:ext>
            </a:extLst>
          </p:cNvPr>
          <p:cNvSpPr/>
          <p:nvPr/>
        </p:nvSpPr>
        <p:spPr>
          <a:xfrm>
            <a:off x="58004" y="196327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テキスト ボックス 16">
            <a:extLst>
              <a:ext uri="{FF2B5EF4-FFF2-40B4-BE49-F238E27FC236}">
                <a16:creationId xmlns:a16="http://schemas.microsoft.com/office/drawing/2014/main" id="{EA1D7486-26F7-7149-88C9-58F1A941F08D}"/>
              </a:ext>
            </a:extLst>
          </p:cNvPr>
          <p:cNvSpPr txBox="1"/>
          <p:nvPr/>
        </p:nvSpPr>
        <p:spPr>
          <a:xfrm>
            <a:off x="33290" y="422703"/>
            <a:ext cx="540724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>
                <a:latin typeface="Arial"/>
                <a:cs typeface="Arial"/>
              </a:rPr>
              <a:t>S3 Table. </a:t>
            </a:r>
            <a:r>
              <a:rPr lang="en-US" altLang="ja-JP" sz="1050" dirty="0">
                <a:latin typeface="Arial"/>
                <a:cs typeface="Arial"/>
              </a:rPr>
              <a:t>List of NLR and corresponding AVR effector used in the cell death assays.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3" name="テキスト ボックス 17">
            <a:extLst>
              <a:ext uri="{FF2B5EF4-FFF2-40B4-BE49-F238E27FC236}">
                <a16:creationId xmlns:a16="http://schemas.microsoft.com/office/drawing/2014/main" id="{E5BCFA6A-4C52-8E40-ADC8-0EC145478D29}"/>
              </a:ext>
            </a:extLst>
          </p:cNvPr>
          <p:cNvSpPr txBox="1"/>
          <p:nvPr/>
        </p:nvSpPr>
        <p:spPr>
          <a:xfrm>
            <a:off x="548072" y="714225"/>
            <a:ext cx="91082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Gene name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6" name="テキスト ボックス 19">
            <a:extLst>
              <a:ext uri="{FF2B5EF4-FFF2-40B4-BE49-F238E27FC236}">
                <a16:creationId xmlns:a16="http://schemas.microsoft.com/office/drawing/2014/main" id="{0AEACA27-73E9-334D-91A5-E0A0BC92B942}"/>
              </a:ext>
            </a:extLst>
          </p:cNvPr>
          <p:cNvSpPr txBox="1"/>
          <p:nvPr/>
        </p:nvSpPr>
        <p:spPr>
          <a:xfrm>
            <a:off x="5276071" y="714225"/>
            <a:ext cx="83869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Reference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cxnSp>
        <p:nvCxnSpPr>
          <p:cNvPr id="48" name="直線コネクタ 20">
            <a:extLst>
              <a:ext uri="{FF2B5EF4-FFF2-40B4-BE49-F238E27FC236}">
                <a16:creationId xmlns:a16="http://schemas.microsoft.com/office/drawing/2014/main" id="{5FD7A773-5199-8B4F-B10F-120103137820}"/>
              </a:ext>
            </a:extLst>
          </p:cNvPr>
          <p:cNvCxnSpPr/>
          <p:nvPr/>
        </p:nvCxnSpPr>
        <p:spPr>
          <a:xfrm flipV="1">
            <a:off x="51175" y="975666"/>
            <a:ext cx="6754598" cy="2006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21">
            <a:extLst>
              <a:ext uri="{FF2B5EF4-FFF2-40B4-BE49-F238E27FC236}">
                <a16:creationId xmlns:a16="http://schemas.microsoft.com/office/drawing/2014/main" id="{E6A126DE-3919-9A43-94F7-C6D9EB177297}"/>
              </a:ext>
            </a:extLst>
          </p:cNvPr>
          <p:cNvCxnSpPr/>
          <p:nvPr/>
        </p:nvCxnSpPr>
        <p:spPr>
          <a:xfrm>
            <a:off x="51175" y="694242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22">
            <a:extLst>
              <a:ext uri="{FF2B5EF4-FFF2-40B4-BE49-F238E27FC236}">
                <a16:creationId xmlns:a16="http://schemas.microsoft.com/office/drawing/2014/main" id="{BA753104-4C82-B949-850A-96F48C6983B5}"/>
              </a:ext>
            </a:extLst>
          </p:cNvPr>
          <p:cNvCxnSpPr/>
          <p:nvPr/>
        </p:nvCxnSpPr>
        <p:spPr>
          <a:xfrm>
            <a:off x="51175" y="7200030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23">
            <a:extLst>
              <a:ext uri="{FF2B5EF4-FFF2-40B4-BE49-F238E27FC236}">
                <a16:creationId xmlns:a16="http://schemas.microsoft.com/office/drawing/2014/main" id="{F3A84349-F144-F445-88B3-7050FCE92CE6}"/>
              </a:ext>
            </a:extLst>
          </p:cNvPr>
          <p:cNvSpPr txBox="1"/>
          <p:nvPr/>
        </p:nvSpPr>
        <p:spPr>
          <a:xfrm>
            <a:off x="553583" y="1003487"/>
            <a:ext cx="803425" cy="62478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Pto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SlPrf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AvrPtoB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Gpa2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GpRBP1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pi-blb2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AVRblb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AVR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Sw-5b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NSm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x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CP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R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AVR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3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AVR3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2</a:t>
            </a:r>
            <a:r>
              <a:rPr lang="it-IT" altLang="ja-JP" sz="1000" baseline="30000" dirty="0">
                <a:latin typeface="Arial" charset="0"/>
                <a:ea typeface="Arial" charset="0"/>
                <a:cs typeface="Arial" charset="0"/>
              </a:rPr>
              <a:t>H480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NRC3</a:t>
            </a:r>
            <a:r>
              <a:rPr lang="en-US" altLang="ja-JP" sz="1000" baseline="30000" dirty="0">
                <a:latin typeface="Arial" charset="0"/>
                <a:ea typeface="Arial" charset="0"/>
                <a:cs typeface="Arial" charset="0"/>
              </a:rPr>
              <a:t>D480V</a:t>
            </a:r>
            <a:endParaRPr lang="en-GB" altLang="ja-JP" sz="1000" baseline="30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NRC4</a:t>
            </a:r>
            <a:r>
              <a:rPr lang="en-US" altLang="ja-JP" sz="1000" baseline="30000" dirty="0">
                <a:latin typeface="Arial" charset="0"/>
                <a:ea typeface="Arial" charset="0"/>
                <a:cs typeface="Arial" charset="0"/>
              </a:rPr>
              <a:t>D478V</a:t>
            </a:r>
            <a:endParaRPr lang="en-GB" altLang="ja-JP" sz="1000" baseline="30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7" name="テキスト ボックス 18">
            <a:extLst>
              <a:ext uri="{FF2B5EF4-FFF2-40B4-BE49-F238E27FC236}">
                <a16:creationId xmlns:a16="http://schemas.microsoft.com/office/drawing/2014/main" id="{1858C293-F58B-A54D-B7ED-9B7C1F084D9D}"/>
              </a:ext>
            </a:extLst>
          </p:cNvPr>
          <p:cNvSpPr txBox="1"/>
          <p:nvPr/>
        </p:nvSpPr>
        <p:spPr>
          <a:xfrm>
            <a:off x="3353017" y="714225"/>
            <a:ext cx="15744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Concentration (OD</a:t>
            </a:r>
            <a:r>
              <a:rPr lang="en-US" altLang="ja-JP" sz="1050" b="1" baseline="-25000" dirty="0">
                <a:latin typeface="Arial"/>
                <a:cs typeface="Arial"/>
              </a:rPr>
              <a:t>600</a:t>
            </a:r>
            <a:r>
              <a:rPr lang="en-US" altLang="ja-JP" sz="1050" b="1" dirty="0">
                <a:latin typeface="Arial"/>
                <a:cs typeface="Arial"/>
              </a:rPr>
              <a:t>)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28" name="テキスト ボックス 18">
            <a:extLst>
              <a:ext uri="{FF2B5EF4-FFF2-40B4-BE49-F238E27FC236}">
                <a16:creationId xmlns:a16="http://schemas.microsoft.com/office/drawing/2014/main" id="{5848BF39-CFD9-BA43-9A22-763DBBC3B11C}"/>
              </a:ext>
            </a:extLst>
          </p:cNvPr>
          <p:cNvSpPr txBox="1"/>
          <p:nvPr/>
        </p:nvSpPr>
        <p:spPr>
          <a:xfrm>
            <a:off x="1974733" y="714225"/>
            <a:ext cx="4235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Tag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29" name="テキスト ボックス 23">
            <a:extLst>
              <a:ext uri="{FF2B5EF4-FFF2-40B4-BE49-F238E27FC236}">
                <a16:creationId xmlns:a16="http://schemas.microsoft.com/office/drawing/2014/main" id="{F937FAC2-B5C1-464F-825B-BA8A59741A86}"/>
              </a:ext>
            </a:extLst>
          </p:cNvPr>
          <p:cNvSpPr txBox="1"/>
          <p:nvPr/>
        </p:nvSpPr>
        <p:spPr>
          <a:xfrm>
            <a:off x="1951122" y="995727"/>
            <a:ext cx="1144865" cy="6401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C-terminal GFP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C-terminal 3xHA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Untagged</a:t>
            </a: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-terminal GFP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-terminal FLAG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-terminal GFP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C-terminal H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C-terminal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csBP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Untagged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-terminal GFP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1" name="テキスト ボックス 23">
            <a:extLst>
              <a:ext uri="{FF2B5EF4-FFF2-40B4-BE49-F238E27FC236}">
                <a16:creationId xmlns:a16="http://schemas.microsoft.com/office/drawing/2014/main" id="{916B14EC-3B86-BC4E-8B70-14B352A3D6C0}"/>
              </a:ext>
            </a:extLst>
          </p:cNvPr>
          <p:cNvSpPr txBox="1"/>
          <p:nvPr/>
        </p:nvSpPr>
        <p:spPr>
          <a:xfrm>
            <a:off x="3905762" y="1003487"/>
            <a:ext cx="431528" cy="62478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2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2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0.2</a:t>
            </a: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5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5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1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5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5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0.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0.3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3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5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25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25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2" name="テキスト ボックス 23">
            <a:extLst>
              <a:ext uri="{FF2B5EF4-FFF2-40B4-BE49-F238E27FC236}">
                <a16:creationId xmlns:a16="http://schemas.microsoft.com/office/drawing/2014/main" id="{9973E583-AA61-7A48-B7CB-4920B76C6CC8}"/>
              </a:ext>
            </a:extLst>
          </p:cNvPr>
          <p:cNvSpPr txBox="1"/>
          <p:nvPr/>
        </p:nvSpPr>
        <p:spPr>
          <a:xfrm>
            <a:off x="5169926" y="999674"/>
            <a:ext cx="975316" cy="6247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1,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2</a:t>
            </a:r>
            <a:endParaRPr kumimoji="1" lang="en-US" altLang="ja-JP" sz="1000" dirty="0">
              <a:latin typeface="Arial"/>
              <a:cs typeface="Arial"/>
            </a:endParaRPr>
          </a:p>
          <a:p>
            <a:pPr algn="ctr"/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3</a:t>
            </a:r>
          </a:p>
          <a:p>
            <a:pPr algn="ctr"/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3</a:t>
            </a:r>
          </a:p>
          <a:p>
            <a:pPr algn="ctr"/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4</a:t>
            </a:r>
          </a:p>
          <a:p>
            <a:pPr algn="ctr"/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4</a:t>
            </a:r>
          </a:p>
          <a:p>
            <a:pPr algn="ctr"/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5</a:t>
            </a:r>
          </a:p>
          <a:p>
            <a:pPr algn="ctr"/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5</a:t>
            </a:r>
          </a:p>
          <a:p>
            <a:pPr algn="ctr"/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6,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7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6,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8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9</a:t>
            </a:r>
          </a:p>
          <a:p>
            <a:pPr algn="ctr"/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10</a:t>
            </a:r>
          </a:p>
          <a:p>
            <a:pPr algn="ctr"/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11,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12</a:t>
            </a:r>
          </a:p>
          <a:p>
            <a:pPr algn="ctr"/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12</a:t>
            </a:r>
          </a:p>
          <a:p>
            <a:pPr algn="ctr"/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13</a:t>
            </a:r>
          </a:p>
          <a:p>
            <a:pPr algn="ctr"/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14</a:t>
            </a:r>
          </a:p>
          <a:p>
            <a:pPr algn="ctr"/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15</a:t>
            </a:r>
          </a:p>
          <a:p>
            <a:pPr algn="ctr"/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15</a:t>
            </a:r>
          </a:p>
          <a:p>
            <a:pPr algn="ctr"/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16</a:t>
            </a:r>
          </a:p>
          <a:p>
            <a:pPr algn="ctr"/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16</a:t>
            </a:r>
          </a:p>
          <a:p>
            <a:pPr algn="ctr"/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1000">
                <a:latin typeface="Arial" charset="0"/>
                <a:ea typeface="Arial" charset="0"/>
                <a:cs typeface="Arial" charset="0"/>
              </a:rPr>
              <a:t>17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69580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8FE003D-E7CF-ABAA-D6FB-B73536D5BCF4}"/>
              </a:ext>
            </a:extLst>
          </p:cNvPr>
          <p:cNvSpPr txBox="1"/>
          <p:nvPr/>
        </p:nvSpPr>
        <p:spPr>
          <a:xfrm>
            <a:off x="408482" y="149901"/>
            <a:ext cx="6041036" cy="93256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eference</a:t>
            </a:r>
            <a:endParaRPr lang="ja-JP" altLang="ja-JP" sz="10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0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 </a:t>
            </a:r>
            <a:endParaRPr lang="ja-JP" altLang="ja-JP" sz="10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e Vries JS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ndriotis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VM, Wu AJ, Rathjen JP. Tomato </a:t>
            </a:r>
            <a:r>
              <a:rPr lang="en-GB" altLang="ja-JP" sz="10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to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encodes a functional N-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yristoylation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motif that is required for signal transduction in </a:t>
            </a:r>
            <a:r>
              <a:rPr lang="en-GB" altLang="ja-JP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icotiana </a:t>
            </a:r>
            <a:r>
              <a:rPr lang="en-GB" altLang="ja-JP" sz="10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enthamiana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Plant J. 2006; 45:31-45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111/j.1365-313X.2005.02590.x. 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athjen JP, Chang JH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taskawicz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BJ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ichelmore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RW. Constitutively active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to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induces a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f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dependent hypersensitive response in the absence of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vrPto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EMBO J. 1999; 18:3232-3240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093/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mboj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/18.12.3232. 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ucyn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TS, Clemente A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ndriotis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VM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almuth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L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ldroyd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GE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taskawicz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BJ, et al. The tomato NBARC-LRR protein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f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interacts with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to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kinase in vivo to regulate specific plant immunity. Plant Cell. 2006; 18:2792-2806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105/tpc.106.044016. 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it-IT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acco MA, </a:t>
            </a:r>
            <a:r>
              <a:rPr lang="it-IT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oropacka</a:t>
            </a:r>
            <a:r>
              <a:rPr lang="it-IT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K, Grenier E, </a:t>
            </a:r>
            <a:r>
              <a:rPr lang="it-IT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Jaubert</a:t>
            </a:r>
            <a:r>
              <a:rPr lang="it-IT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MJ, Blanchard A, </a:t>
            </a:r>
            <a:r>
              <a:rPr lang="it-IT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overse</a:t>
            </a:r>
            <a:r>
              <a:rPr lang="it-IT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, et al. 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cyst nematode SPRYSEC protein RBP-1 elicits Gpa2- and RanGAP2-dependent plant cell death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LoS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athog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2009; 5:e1000564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371/journal.ppat.1000564. 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ozkurt TO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chornack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S, Win J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indo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T, Ilyas M, Oliva R, et al. </a:t>
            </a:r>
            <a:r>
              <a:rPr lang="en-GB" altLang="ja-JP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hytophthora </a:t>
            </a:r>
            <a:r>
              <a:rPr lang="en-GB" altLang="ja-JP" sz="10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festans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effector AVRblb2 prevents secretion of a plant immune protease at the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austorial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interface. Proc Natl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cad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Sci U S A. 2011; 108:20832-20837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073/pnas.1112708109. 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Wu CH, Abd-El-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aliem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, Bozkurt TO, Belhaj K, Terauchi R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Vossen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JH, et al. NLR network mediates immunity to diverse plant pathogens. Proc Natl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cad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Sci U S A. 2017; 114:8113-8118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073/pnas.1702041114.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allvora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rcolano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MR, Weiss J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eksem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K, Bormann CA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berhagemann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P, et al. The R1 gene for potato resistance to late blight (Phytophthora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festans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 belongs to the leucine zipper/NBS/LRR class of plant resistance genes. Plant J. 2002; 30:361-371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046/j.1365-313x.2001.01292.x. 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u Y, Berg J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overs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F, Bouwmeester K. Immune activation mediated by the late blight resistance protein R1 requires nuclear localization of R1 and the effector AVR1. New Phytol. 2015; 207:735-747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111/nph.13355. 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passova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MI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ins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TW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olkertsma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RT, Klein-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Lankhorst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RM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ille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J, Goldbach RW, et al. The tomato gene </a:t>
            </a:r>
            <a:r>
              <a:rPr lang="en-GB" altLang="ja-JP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w5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is a member of the coiled coil, nucleotide binding, leucine-rich repeat class of plant resistance genes and confers resistance to TSWV in tobacco. Molecular Breeding. 2001; 7:151-161. doi:10.1023/A:1011363119763.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allwass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M, de Oliveira AS, de Campos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ianese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E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Lohuis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D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oiteux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LS, Inoue-Nagata AK, et al. The </a:t>
            </a:r>
            <a:r>
              <a:rPr lang="en-GB" altLang="ja-JP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omato spotted wilt virus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ell-to-cell movement protein (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Sm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 triggers a hypersensitive response in </a:t>
            </a:r>
            <a:r>
              <a:rPr lang="en-GB" altLang="ja-JP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w-5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containing resistant tomato lines and in </a:t>
            </a:r>
            <a:r>
              <a:rPr lang="en-GB" altLang="ja-JP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icotiana </a:t>
            </a:r>
            <a:r>
              <a:rPr lang="en-GB" altLang="ja-JP" sz="10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enthamiana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transformed with the functional </a:t>
            </a:r>
            <a:r>
              <a:rPr lang="en-GB" altLang="ja-JP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w-5b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resistance gene copy. Mol Plant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athol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2014; 15:871-880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111/mpp.12144.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Lu R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alcuit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I, Moffett P, Ruiz MT, Peart J, Wu AJ, et al. High throughput virus-induced gene silencing implicates heat shock protein 90 in plant disease resistance. EMBO J. 2003; 22:5690-5699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093/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mboj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/cdg546.  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ameling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WI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aulcombe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DC. Physical association of the NB-LRR resistance protein Rx with a Ran GTPase-activating protein is required for extreme resistance to Potato virus X. Plant Cell. 2007; 19:1682-1694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105/tpc.107.050880. 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Lokossou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A, Park TH, van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rkel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G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rens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M, Ruyter-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pira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, Morales J, et al. Exploiting knowledge of R/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vr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genes to rapidly clone a new LZ-NBS-LRR family of late blight resistance genes from potato linkage group IV. Mol Plant Microbe Interact. 2009; 22:630-641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094/MPMI-22-6-0630. 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>
              <a:buFont typeface="+mj-lt"/>
              <a:buAutoNum type="arabicPeriod"/>
            </a:pP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aunders DG, Breen S, Win J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chornack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S, Hein I, Bozkurt TO, et al. Host protein BSL1 associates with </a:t>
            </a:r>
            <a:r>
              <a:rPr lang="en-GB" altLang="ja-JP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hytophthora </a:t>
            </a:r>
            <a:r>
              <a:rPr lang="en-GB" altLang="ja-JP" sz="10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festans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RXLR effector AVR2 and the </a:t>
            </a:r>
            <a:r>
              <a:rPr lang="en-GB" altLang="ja-JP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olanum </a:t>
            </a:r>
            <a:r>
              <a:rPr lang="en-GB" altLang="ja-JP" sz="10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emissum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Immune receptor R2 to mediate disease resistance. Plant Cell. 2012; 24:3420-3434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105/tpc.112.099861. 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os JI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annegant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TD, Young C,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akir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, Huitema E, Win J, et al. The C-terminal half of </a:t>
            </a:r>
            <a:r>
              <a:rPr lang="en-GB" altLang="ja-JP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hytophthora </a:t>
            </a:r>
            <a:r>
              <a:rPr lang="en-GB" altLang="ja-JP" sz="10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festans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RXLR effector AVR3a is sufficient to trigger R3a-mediated hypersensitivity and suppress INF1-induced cell death in </a:t>
            </a:r>
            <a:r>
              <a:rPr lang="en-GB" altLang="ja-JP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icotiana </a:t>
            </a:r>
            <a:r>
              <a:rPr lang="en-GB" altLang="ja-JP" sz="10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enthamiana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Plant J. 2006; 48:165-176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111/j.1365-313X.2006.02866.x. </a:t>
            </a:r>
            <a:endParaRPr lang="ja-JP" altLang="ja-JP" sz="10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it-IT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erevnina</a:t>
            </a:r>
            <a:r>
              <a:rPr lang="it-IT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L, Contreras MP, </a:t>
            </a:r>
            <a:r>
              <a:rPr lang="it-IT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dachi</a:t>
            </a:r>
            <a:r>
              <a:rPr lang="it-IT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H, </a:t>
            </a:r>
            <a:r>
              <a:rPr lang="it-IT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Upson</a:t>
            </a:r>
            <a:r>
              <a:rPr lang="it-IT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it-IT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J</a:t>
            </a:r>
            <a:r>
              <a:rPr lang="it-IT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Vergara </a:t>
            </a:r>
            <a:r>
              <a:rPr lang="it-IT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ruces</a:t>
            </a:r>
            <a:r>
              <a:rPr lang="it-IT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, </a:t>
            </a:r>
            <a:r>
              <a:rPr lang="it-IT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Xie</a:t>
            </a:r>
            <a:r>
              <a:rPr lang="it-IT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it-IT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</a:t>
            </a:r>
            <a:r>
              <a:rPr lang="it-IT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et al. 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lant pathogens convergently evolved to counteract redundant nodes of an NLR immune receptor network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LoS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Biol. 2021; 19:e3001136. </a:t>
            </a:r>
            <a:r>
              <a:rPr lang="en-GB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1371/journal.pbio.3001136. </a:t>
            </a:r>
            <a:endParaRPr lang="en-US" altLang="ja-JP" sz="10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42900" lvl="0" indent="-342900" algn="just">
              <a:buFont typeface="+mj-lt"/>
              <a:buAutoNum type="arabicPeriod"/>
            </a:pP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dachi H, Contreras MP, </a:t>
            </a:r>
            <a:r>
              <a:rPr lang="en-US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arant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, Wu CH, </a:t>
            </a:r>
            <a:r>
              <a:rPr lang="en-US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erevnina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L, Sakai T, et al. An N-terminal motif in NLR immune receptors is functionally conserved across distantly related plant species. </a:t>
            </a:r>
            <a:r>
              <a:rPr lang="en-US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life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2019; 8:e49956. </a:t>
            </a:r>
            <a:r>
              <a:rPr lang="en-US" altLang="ja-JP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oi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10.7554/eLife.49956. 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52977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3</TotalTime>
  <Words>1065</Words>
  <Application>Microsoft Macintosh PowerPoint</Application>
  <PresentationFormat>A4 210 x 297 mm</PresentationFormat>
  <Paragraphs>18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aki Adachi (TSL)</dc:creator>
  <cp:lastModifiedBy>Adachi Hiroaki</cp:lastModifiedBy>
  <cp:revision>54</cp:revision>
  <dcterms:created xsi:type="dcterms:W3CDTF">2019-04-29T00:03:08Z</dcterms:created>
  <dcterms:modified xsi:type="dcterms:W3CDTF">2022-12-06T10:10:05Z</dcterms:modified>
</cp:coreProperties>
</file>